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FD8678-A581-469F-84A3-252009AE9361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734E42-4782-4412-9508-F7F05103E5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80194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734E42-4782-4412-9508-F7F05103E55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60019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5501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173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9869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9915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5507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554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904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1217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5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817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042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FD63E-5833-4BBC-8DBC-14AA9F4AEA85}" type="datetimeFigureOut">
              <a:rPr lang="en-GB" smtClean="0"/>
              <a:t>24/0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2E87D-F566-4975-9F68-4B6EF5A96E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3050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43608" y="712920"/>
            <a:ext cx="3292519" cy="2098928"/>
            <a:chOff x="1043608" y="712920"/>
            <a:chExt cx="3292519" cy="2098928"/>
          </a:xfrm>
        </p:grpSpPr>
        <p:pic>
          <p:nvPicPr>
            <p:cNvPr id="53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32" t="27545" r="32340" b="38728"/>
            <a:stretch/>
          </p:blipFill>
          <p:spPr bwMode="auto">
            <a:xfrm>
              <a:off x="1456127" y="1146036"/>
              <a:ext cx="2880000" cy="16658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4" name="Group 53"/>
            <p:cNvGrpSpPr/>
            <p:nvPr/>
          </p:nvGrpSpPr>
          <p:grpSpPr>
            <a:xfrm>
              <a:off x="1043608" y="802814"/>
              <a:ext cx="666509" cy="1974994"/>
              <a:chOff x="136481" y="294953"/>
              <a:chExt cx="666509" cy="1974994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490084" y="419919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M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136481" y="294953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>
                <a:off x="440680" y="2123728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440680" y="87101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440680" y="1663105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>
                <a:off x="188640" y="72166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66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88640" y="1159049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189135" y="1547664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3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88640" y="199294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66" name="Straight Connector 65"/>
              <p:cNvCxnSpPr/>
              <p:nvPr/>
            </p:nvCxnSpPr>
            <p:spPr>
              <a:xfrm>
                <a:off x="440680" y="130725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/>
            <p:cNvSpPr txBox="1"/>
            <p:nvPr/>
          </p:nvSpPr>
          <p:spPr>
            <a:xfrm>
              <a:off x="2607935" y="712920"/>
              <a:ext cx="12843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Increasing  BS</a:t>
              </a:r>
              <a:r>
                <a:rPr lang="en-GB" sz="12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6" name="Straight Arrow Connector 55"/>
            <p:cNvCxnSpPr/>
            <p:nvPr/>
          </p:nvCxnSpPr>
          <p:spPr>
            <a:xfrm>
              <a:off x="2175887" y="989918"/>
              <a:ext cx="2052000" cy="1"/>
            </a:xfrm>
            <a:prstGeom prst="straightConnector1">
              <a:avLst/>
            </a:prstGeom>
            <a:ln w="19050">
              <a:solidFill>
                <a:schemeClr val="tx1">
                  <a:lumMod val="75000"/>
                  <a:lumOff val="2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oup 66"/>
          <p:cNvGrpSpPr/>
          <p:nvPr/>
        </p:nvGrpSpPr>
        <p:grpSpPr>
          <a:xfrm>
            <a:off x="4696487" y="692696"/>
            <a:ext cx="2880000" cy="2160240"/>
            <a:chOff x="3789360" y="1547664"/>
            <a:chExt cx="2880000" cy="2160240"/>
          </a:xfrm>
        </p:grpSpPr>
        <p:grpSp>
          <p:nvGrpSpPr>
            <p:cNvPr id="68" name="Group 67"/>
            <p:cNvGrpSpPr/>
            <p:nvPr/>
          </p:nvGrpSpPr>
          <p:grpSpPr>
            <a:xfrm>
              <a:off x="3789360" y="1844324"/>
              <a:ext cx="2880000" cy="1863580"/>
              <a:chOff x="3789360" y="481495"/>
              <a:chExt cx="2880000" cy="1863580"/>
            </a:xfrm>
          </p:grpSpPr>
          <p:pic>
            <p:nvPicPr>
              <p:cNvPr id="70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64" t="20380" r="32122" b="43555"/>
              <a:stretch/>
            </p:blipFill>
            <p:spPr bwMode="auto">
              <a:xfrm>
                <a:off x="3789360" y="638175"/>
                <a:ext cx="2880000" cy="17069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71" name="Straight Arrow Connector 70"/>
              <p:cNvCxnSpPr/>
              <p:nvPr/>
            </p:nvCxnSpPr>
            <p:spPr>
              <a:xfrm>
                <a:off x="4487858" y="481495"/>
                <a:ext cx="2052000" cy="1"/>
              </a:xfrm>
              <a:prstGeom prst="straightConnector1">
                <a:avLst/>
              </a:prstGeom>
              <a:ln w="19050"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TextBox 68"/>
            <p:cNvSpPr txBox="1"/>
            <p:nvPr/>
          </p:nvSpPr>
          <p:spPr>
            <a:xfrm>
              <a:off x="4797152" y="1547664"/>
              <a:ext cx="12843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Increasing  BS</a:t>
              </a:r>
              <a:r>
                <a:rPr lang="en-GB" sz="12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1043608" y="3765861"/>
            <a:ext cx="3373732" cy="2687475"/>
            <a:chOff x="1043608" y="3765861"/>
            <a:chExt cx="3373732" cy="2687475"/>
          </a:xfrm>
        </p:grpSpPr>
        <p:pic>
          <p:nvPicPr>
            <p:cNvPr id="85" name="Picture 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95" t="21105" r="21356" b="38651"/>
            <a:stretch/>
          </p:blipFill>
          <p:spPr bwMode="auto">
            <a:xfrm>
              <a:off x="1465332" y="4974784"/>
              <a:ext cx="2880000" cy="14785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" name="Group 1"/>
            <p:cNvGrpSpPr/>
            <p:nvPr/>
          </p:nvGrpSpPr>
          <p:grpSpPr>
            <a:xfrm>
              <a:off x="1043608" y="4647073"/>
              <a:ext cx="666509" cy="1795230"/>
              <a:chOff x="1043608" y="4647073"/>
              <a:chExt cx="666509" cy="1795230"/>
            </a:xfrm>
          </p:grpSpPr>
          <p:sp>
            <p:nvSpPr>
              <p:cNvPr id="96" name="TextBox 95"/>
              <p:cNvSpPr txBox="1"/>
              <p:nvPr/>
            </p:nvSpPr>
            <p:spPr>
              <a:xfrm>
                <a:off x="1397211" y="475352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M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1043608" y="4647073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8" name="Straight Connector 97"/>
              <p:cNvCxnSpPr/>
              <p:nvPr/>
            </p:nvCxnSpPr>
            <p:spPr>
              <a:xfrm>
                <a:off x="1347807" y="629608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1347807" y="5294813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>
                <a:off x="1347807" y="5941377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TextBox 100"/>
              <p:cNvSpPr txBox="1"/>
              <p:nvPr/>
            </p:nvSpPr>
            <p:spPr>
              <a:xfrm>
                <a:off x="1095767" y="516822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66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1095767" y="552826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096262" y="5805264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3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1095767" y="6165304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25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05" name="Straight Connector 104"/>
              <p:cNvCxnSpPr/>
              <p:nvPr/>
            </p:nvCxnSpPr>
            <p:spPr>
              <a:xfrm>
                <a:off x="1347807" y="5668570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Group 105"/>
            <p:cNvGrpSpPr/>
            <p:nvPr/>
          </p:nvGrpSpPr>
          <p:grpSpPr>
            <a:xfrm>
              <a:off x="2496001" y="3939748"/>
              <a:ext cx="1908664" cy="1069524"/>
              <a:chOff x="2506645" y="3530879"/>
              <a:chExt cx="1908664" cy="1069524"/>
            </a:xfrm>
          </p:grpSpPr>
          <p:sp>
            <p:nvSpPr>
              <p:cNvPr id="90" name="TextBox 89"/>
              <p:cNvSpPr txBox="1"/>
              <p:nvPr/>
            </p:nvSpPr>
            <p:spPr>
              <a:xfrm rot="17828457">
                <a:off x="3742048" y="3927141"/>
                <a:ext cx="10695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Nicotinamide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 rot="17828457">
                <a:off x="3476900" y="4004115"/>
                <a:ext cx="8402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Curcumin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 rot="17828457">
                <a:off x="3138367" y="3961684"/>
                <a:ext cx="9589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Dicoumarol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 rot="17828457">
                <a:off x="2847720" y="3952947"/>
                <a:ext cx="9685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Resveratrol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 rot="17828457">
                <a:off x="2635688" y="4073068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 smtClean="0">
                    <a:latin typeface="Arial" pitchFamily="34" charset="0"/>
                    <a:cs typeface="Arial" pitchFamily="34" charset="0"/>
                  </a:rPr>
                  <a:t>NaOH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 rot="17828457">
                <a:off x="2321979" y="4052483"/>
                <a:ext cx="6463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DMSO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88" name="Straight Connector 87"/>
            <p:cNvCxnSpPr/>
            <p:nvPr/>
          </p:nvCxnSpPr>
          <p:spPr>
            <a:xfrm>
              <a:off x="2130260" y="4037527"/>
              <a:ext cx="2287080" cy="533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3044644" y="3765861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+ BS</a:t>
              </a:r>
              <a:r>
                <a:rPr lang="en-GB" sz="12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4705651" y="3717032"/>
            <a:ext cx="2934873" cy="2710855"/>
            <a:chOff x="4932319" y="3356992"/>
            <a:chExt cx="2934873" cy="2710855"/>
          </a:xfrm>
        </p:grpSpPr>
        <p:pic>
          <p:nvPicPr>
            <p:cNvPr id="75" name="Picture 3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53" t="22733" r="19256" b="34885"/>
            <a:stretch/>
          </p:blipFill>
          <p:spPr bwMode="auto">
            <a:xfrm>
              <a:off x="4932319" y="4543247"/>
              <a:ext cx="2880000" cy="1524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7" name="TextBox 106"/>
            <p:cNvSpPr txBox="1"/>
            <p:nvPr/>
          </p:nvSpPr>
          <p:spPr>
            <a:xfrm rot="17828457">
              <a:off x="7181256" y="3927141"/>
              <a:ext cx="10695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Nicotinamide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 rot="17828457">
              <a:off x="6916108" y="4004115"/>
              <a:ext cx="8402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Curcumin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 rot="17828457">
              <a:off x="6577575" y="3961684"/>
              <a:ext cx="9589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Dicoumarol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 rot="17828457">
              <a:off x="6286928" y="3952947"/>
              <a:ext cx="9685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Resveratrol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7828457">
              <a:off x="6074896" y="4073068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NaOH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 rot="17828457">
              <a:off x="5761187" y="4052483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DMSO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3" name="Straight Connector 112"/>
            <p:cNvCxnSpPr/>
            <p:nvPr/>
          </p:nvCxnSpPr>
          <p:spPr>
            <a:xfrm>
              <a:off x="5580112" y="3628658"/>
              <a:ext cx="2287080" cy="533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6494496" y="3356992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+ BS</a:t>
              </a:r>
              <a:r>
                <a:rPr lang="en-GB" sz="12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8" name="TextBox 117"/>
          <p:cNvSpPr txBox="1"/>
          <p:nvPr/>
        </p:nvSpPr>
        <p:spPr>
          <a:xfrm>
            <a:off x="683568" y="188640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(a)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683568" y="3140968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(b)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7" name="Straight Arrow Connector 116"/>
          <p:cNvCxnSpPr/>
          <p:nvPr/>
        </p:nvCxnSpPr>
        <p:spPr>
          <a:xfrm flipH="1">
            <a:off x="7651168" y="2500808"/>
            <a:ext cx="30520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Straight Arrow Connector 121"/>
          <p:cNvCxnSpPr/>
          <p:nvPr/>
        </p:nvCxnSpPr>
        <p:spPr>
          <a:xfrm flipH="1">
            <a:off x="7651168" y="1562308"/>
            <a:ext cx="30520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7916185" y="2362309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Monomer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916185" y="1423809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Dimer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5" name="Straight Arrow Connector 124"/>
          <p:cNvCxnSpPr/>
          <p:nvPr/>
        </p:nvCxnSpPr>
        <p:spPr>
          <a:xfrm flipH="1">
            <a:off x="7651168" y="6090175"/>
            <a:ext cx="30520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Arrow Connector 125"/>
          <p:cNvCxnSpPr/>
          <p:nvPr/>
        </p:nvCxnSpPr>
        <p:spPr>
          <a:xfrm flipH="1">
            <a:off x="7651168" y="5450740"/>
            <a:ext cx="305208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7916185" y="5951676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Monomer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7916185" y="531224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Dimer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2627784" y="354142"/>
            <a:ext cx="10615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NQO2-47F</a:t>
            </a:r>
            <a:endParaRPr lang="en-GB" sz="1600" dirty="0"/>
          </a:p>
        </p:txBody>
      </p:sp>
      <p:sp>
        <p:nvSpPr>
          <p:cNvPr id="130" name="TextBox 129"/>
          <p:cNvSpPr txBox="1"/>
          <p:nvPr/>
        </p:nvSpPr>
        <p:spPr>
          <a:xfrm>
            <a:off x="5724128" y="354142"/>
            <a:ext cx="10534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NQO2-47L</a:t>
            </a:r>
            <a:endParaRPr lang="en-GB" sz="1600" dirty="0"/>
          </a:p>
        </p:txBody>
      </p:sp>
      <p:sp>
        <p:nvSpPr>
          <p:cNvPr id="131" name="TextBox 130"/>
          <p:cNvSpPr txBox="1"/>
          <p:nvPr/>
        </p:nvSpPr>
        <p:spPr>
          <a:xfrm>
            <a:off x="2627784" y="3429000"/>
            <a:ext cx="10615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NQO2-47F</a:t>
            </a:r>
            <a:endParaRPr lang="en-GB" sz="1600" dirty="0"/>
          </a:p>
        </p:txBody>
      </p:sp>
      <p:sp>
        <p:nvSpPr>
          <p:cNvPr id="132" name="TextBox 131"/>
          <p:cNvSpPr txBox="1"/>
          <p:nvPr/>
        </p:nvSpPr>
        <p:spPr>
          <a:xfrm>
            <a:off x="5724128" y="3429000"/>
            <a:ext cx="10534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NQO2-47L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849023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47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re Megarity</dc:creator>
  <cp:lastModifiedBy>2111446</cp:lastModifiedBy>
  <cp:revision>8</cp:revision>
  <dcterms:created xsi:type="dcterms:W3CDTF">2013-11-08T11:31:16Z</dcterms:created>
  <dcterms:modified xsi:type="dcterms:W3CDTF">2014-01-24T12:06:58Z</dcterms:modified>
</cp:coreProperties>
</file>